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331" r:id="rId2"/>
    <p:sldId id="342" r:id="rId3"/>
    <p:sldId id="332" r:id="rId4"/>
    <p:sldId id="343" r:id="rId5"/>
    <p:sldId id="338" r:id="rId6"/>
    <p:sldId id="339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816"/>
    <p:restoredTop sz="95820" autoAdjust="0"/>
  </p:normalViewPr>
  <p:slideViewPr>
    <p:cSldViewPr snapToGrid="0">
      <p:cViewPr>
        <p:scale>
          <a:sx n="125" d="100"/>
          <a:sy n="125" d="100"/>
        </p:scale>
        <p:origin x="739" y="-30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4336E7-52B8-C742-9618-D0797C31BE30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789B36-53C7-9041-B440-66695ECF8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322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845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211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96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472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834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63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282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171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958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975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609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E5852-D631-654F-A42A-E357EEF61D8C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96C5A-F812-9642-9C1F-B612E16256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592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3.emf"/><Relationship Id="rId4" Type="http://schemas.openxmlformats.org/officeDocument/2006/relationships/image" Target="../media/image11.emf"/><Relationship Id="rId9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emf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>
            <a:extLst>
              <a:ext uri="{FF2B5EF4-FFF2-40B4-BE49-F238E27FC236}">
                <a16:creationId xmlns:a16="http://schemas.microsoft.com/office/drawing/2014/main" id="{84FB28AC-C64D-D400-D600-8F62DF903EFE}"/>
              </a:ext>
            </a:extLst>
          </p:cNvPr>
          <p:cNvSpPr txBox="1"/>
          <p:nvPr/>
        </p:nvSpPr>
        <p:spPr>
          <a:xfrm>
            <a:off x="195943" y="261257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0D2909F-E2DD-74D2-1399-BBE5C58116A9}"/>
              </a:ext>
            </a:extLst>
          </p:cNvPr>
          <p:cNvSpPr txBox="1"/>
          <p:nvPr/>
        </p:nvSpPr>
        <p:spPr>
          <a:xfrm>
            <a:off x="89210" y="2604321"/>
            <a:ext cx="66795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he distribution of TCRB by the count of each clonotype from samples with the highest (left) and lowest (right) sequence yield. X and Y axes were log10 transformed. 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A6D6F0E7-D5C5-40AA-9A88-3162D813D08E}"/>
              </a:ext>
            </a:extLst>
          </p:cNvPr>
          <p:cNvGrpSpPr/>
          <p:nvPr/>
        </p:nvGrpSpPr>
        <p:grpSpPr>
          <a:xfrm>
            <a:off x="924027" y="445923"/>
            <a:ext cx="4741570" cy="2158398"/>
            <a:chOff x="1208708" y="5549801"/>
            <a:chExt cx="4741570" cy="2158398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33E205A-3BF6-CFF5-7ACD-4C029FC1661F}"/>
                </a:ext>
              </a:extLst>
            </p:cNvPr>
            <p:cNvSpPr txBox="1"/>
            <p:nvPr/>
          </p:nvSpPr>
          <p:spPr>
            <a:xfrm rot="16200000">
              <a:off x="962487" y="6238175"/>
              <a:ext cx="8002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  <a:cs typeface="Arial" panose="020B0604020202020204" pitchFamily="34" charset="0"/>
                </a:rPr>
                <a:t>Counts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F9BB1E1-C31B-4097-05D1-A05DD349DC2E}"/>
                </a:ext>
              </a:extLst>
            </p:cNvPr>
            <p:cNvSpPr txBox="1"/>
            <p:nvPr/>
          </p:nvSpPr>
          <p:spPr>
            <a:xfrm>
              <a:off x="2932997" y="7400422"/>
              <a:ext cx="12073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  <a:cs typeface="Arial" panose="020B0604020202020204" pitchFamily="34" charset="0"/>
                </a:rPr>
                <a:t>Clonotypes 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4FC3EC7-5514-553A-3E0B-7E266C28A4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391" t="15459" b="12357"/>
            <a:stretch/>
          </p:blipFill>
          <p:spPr>
            <a:xfrm>
              <a:off x="1516485" y="5549801"/>
              <a:ext cx="2320944" cy="182880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B295599F-704E-441C-992D-573621F1B4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391" t="15459" b="12357"/>
            <a:stretch/>
          </p:blipFill>
          <p:spPr>
            <a:xfrm>
              <a:off x="3629334" y="5549801"/>
              <a:ext cx="2320944" cy="18288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67175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EA9C3B0-1898-89D8-4124-01788303A8CF}"/>
              </a:ext>
            </a:extLst>
          </p:cNvPr>
          <p:cNvSpPr txBox="1"/>
          <p:nvPr/>
        </p:nvSpPr>
        <p:spPr>
          <a:xfrm rot="16200000">
            <a:off x="-893228" y="2512176"/>
            <a:ext cx="27308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% Antigen specific TCR in productive sequence coun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0E42C6-F2AF-A99E-2574-EA75E469596A}"/>
              </a:ext>
            </a:extLst>
          </p:cNvPr>
          <p:cNvSpPr txBox="1"/>
          <p:nvPr/>
        </p:nvSpPr>
        <p:spPr>
          <a:xfrm>
            <a:off x="1472560" y="983828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Spik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4BB837-D4F0-BA8C-C2E1-63D297CD869D}"/>
              </a:ext>
            </a:extLst>
          </p:cNvPr>
          <p:cNvSpPr txBox="1"/>
          <p:nvPr/>
        </p:nvSpPr>
        <p:spPr>
          <a:xfrm>
            <a:off x="3521231" y="98382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AC920D6-938C-3389-0CE4-716D5DB9D79E}"/>
              </a:ext>
            </a:extLst>
          </p:cNvPr>
          <p:cNvSpPr txBox="1"/>
          <p:nvPr/>
        </p:nvSpPr>
        <p:spPr>
          <a:xfrm>
            <a:off x="5127783" y="983828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ORF1a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BBCE43-6213-4B81-2C9E-E53D505D8583}"/>
              </a:ext>
            </a:extLst>
          </p:cNvPr>
          <p:cNvSpPr txBox="1"/>
          <p:nvPr/>
        </p:nvSpPr>
        <p:spPr>
          <a:xfrm rot="5400000">
            <a:off x="5984168" y="1870015"/>
            <a:ext cx="1202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Helvetica" pitchFamily="2" charset="0"/>
              </a:rPr>
              <a:t>LymphoSeq</a:t>
            </a:r>
            <a:endParaRPr lang="en-US" sz="1400" b="1" dirty="0">
              <a:latin typeface="Helvetica" pitchFamily="2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674B19-C14A-B42C-A2D7-7EEB306F84C9}"/>
              </a:ext>
            </a:extLst>
          </p:cNvPr>
          <p:cNvSpPr txBox="1"/>
          <p:nvPr/>
        </p:nvSpPr>
        <p:spPr>
          <a:xfrm rot="5400000">
            <a:off x="5783410" y="3380592"/>
            <a:ext cx="13884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latin typeface="Helvetica" pitchFamily="2" charset="0"/>
              </a:rPr>
              <a:t>ImmuneSEQ</a:t>
            </a:r>
            <a:r>
              <a:rPr lang="en-US" sz="1400" b="1" dirty="0">
                <a:latin typeface="Helvetica" pitchFamily="2" charset="0"/>
              </a:rPr>
              <a:t> Analyzer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BFDDCD3-5698-A4D7-819C-4663EA82F4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3480" y="1182285"/>
            <a:ext cx="1803400" cy="16637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73CB35E-73C6-ED90-D45A-5481AD76ED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7240" y="1182103"/>
            <a:ext cx="1803400" cy="16637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519351D-B445-E4CE-D529-C47CB3F515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47667" y="1178514"/>
            <a:ext cx="1803400" cy="16637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B29F446-BFD2-CD2A-8CD8-F91D897B03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0683" y="2761086"/>
            <a:ext cx="1803400" cy="2082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DBFF90E-F7DE-C8F6-6486-A74499760C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47240" y="2767436"/>
            <a:ext cx="1803400" cy="20701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E4038CA-CF1D-61EB-A4B8-A9311ECF450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47667" y="2775463"/>
            <a:ext cx="1803400" cy="20701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230B709-010D-AE8D-A533-2E8F1FB91DA8}"/>
              </a:ext>
            </a:extLst>
          </p:cNvPr>
          <p:cNvSpPr txBox="1"/>
          <p:nvPr/>
        </p:nvSpPr>
        <p:spPr>
          <a:xfrm>
            <a:off x="195943" y="261257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2757AF2-07E8-35FC-9B79-6E44919C7D03}"/>
              </a:ext>
            </a:extLst>
          </p:cNvPr>
          <p:cNvSpPr txBox="1"/>
          <p:nvPr/>
        </p:nvSpPr>
        <p:spPr>
          <a:xfrm>
            <a:off x="105609" y="7627767"/>
            <a:ext cx="652591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SARS-CoV-2-specific CD8 TCRB among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udy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oups. </a:t>
            </a:r>
          </a:p>
          <a:p>
            <a:pPr algn="just"/>
            <a:r>
              <a:rPr lang="en-US" sz="1200" kern="100" dirty="0">
                <a:latin typeface="Arial" panose="020B0604020202020204" pitchFamily="34" charset="0"/>
                <a:cs typeface="Arial" panose="020B0604020202020204" pitchFamily="34" charset="0"/>
              </a:rPr>
              <a:t>(A) Comparison of the frequencies of SARS-CoV-2-specific CD8 TCRB among study groups using </a:t>
            </a:r>
            <a:r>
              <a:rPr lang="en-US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LymphoSeq</a:t>
            </a:r>
            <a:r>
              <a:rPr lang="en-US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package or the </a:t>
            </a:r>
            <a:r>
              <a:rPr lang="en-US" sz="1200" kern="100" dirty="0" err="1">
                <a:latin typeface="Arial" panose="020B0604020202020204" pitchFamily="34" charset="0"/>
                <a:cs typeface="Arial" panose="020B0604020202020204" pitchFamily="34" charset="0"/>
              </a:rPr>
              <a:t>ImmuneSEQ</a:t>
            </a:r>
            <a:r>
              <a:rPr lang="en-US" sz="1200" kern="100" dirty="0">
                <a:latin typeface="Arial" panose="020B0604020202020204" pitchFamily="34" charset="0"/>
                <a:cs typeface="Arial" panose="020B0604020202020204" pitchFamily="34" charset="0"/>
              </a:rPr>
              <a:t> Analyzer on Adaptive Biotechnologies. </a:t>
            </a:r>
          </a:p>
          <a:p>
            <a:pPr algn="just"/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lation of TCR clonality and age and CCI of participants. P value indicates the significance by Spearman correlation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7D3F314-F640-A208-4945-CA5B18F1693B}"/>
              </a:ext>
            </a:extLst>
          </p:cNvPr>
          <p:cNvSpPr txBox="1"/>
          <p:nvPr/>
        </p:nvSpPr>
        <p:spPr>
          <a:xfrm>
            <a:off x="112360" y="786431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769D42C-D78E-1052-788F-1DDB812B49C1}"/>
              </a:ext>
            </a:extLst>
          </p:cNvPr>
          <p:cNvSpPr txBox="1"/>
          <p:nvPr/>
        </p:nvSpPr>
        <p:spPr>
          <a:xfrm>
            <a:off x="112360" y="4995401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130D668-2559-8A19-FA59-9793B3D24F9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2791" y="5348912"/>
            <a:ext cx="2057400" cy="18415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1102BCC-62F5-920E-34FF-BAEBEB8D06CC}"/>
              </a:ext>
            </a:extLst>
          </p:cNvPr>
          <p:cNvSpPr txBox="1"/>
          <p:nvPr/>
        </p:nvSpPr>
        <p:spPr>
          <a:xfrm>
            <a:off x="1636216" y="5177374"/>
            <a:ext cx="19766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SARS-CoV-2-specifi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19403EB-FF2F-F6D1-CAEC-B663438C1F1C}"/>
              </a:ext>
            </a:extLst>
          </p:cNvPr>
          <p:cNvSpPr txBox="1"/>
          <p:nvPr/>
        </p:nvSpPr>
        <p:spPr>
          <a:xfrm rot="16200000">
            <a:off x="-192650" y="6094579"/>
            <a:ext cx="1467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Clonality scor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D6C47BE-BD98-DE95-D745-4FAE7F89393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99298" y="5348912"/>
            <a:ext cx="2057400" cy="18415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1EF9752-F8A8-DA77-A1C0-69A4EC79EE33}"/>
              </a:ext>
            </a:extLst>
          </p:cNvPr>
          <p:cNvSpPr txBox="1"/>
          <p:nvPr/>
        </p:nvSpPr>
        <p:spPr>
          <a:xfrm>
            <a:off x="3563765" y="7146580"/>
            <a:ext cx="494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CC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81F2E18-45B7-FEA6-F0DD-F01363EC348A}"/>
              </a:ext>
            </a:extLst>
          </p:cNvPr>
          <p:cNvSpPr txBox="1"/>
          <p:nvPr/>
        </p:nvSpPr>
        <p:spPr>
          <a:xfrm>
            <a:off x="1573237" y="7146579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6CCDEC-B0AE-DCA4-348F-CE4605F393A6}"/>
              </a:ext>
            </a:extLst>
          </p:cNvPr>
          <p:cNvSpPr txBox="1"/>
          <p:nvPr/>
        </p:nvSpPr>
        <p:spPr>
          <a:xfrm>
            <a:off x="1771491" y="5587280"/>
            <a:ext cx="8659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P = 0.02</a:t>
            </a:r>
          </a:p>
          <a:p>
            <a:r>
              <a:rPr lang="en-US" sz="1400" dirty="0">
                <a:latin typeface="Helvetica" pitchFamily="2" charset="0"/>
                <a:cs typeface="Arial" panose="020B0604020202020204" pitchFamily="34" charset="0"/>
              </a:rPr>
              <a:t>R = 0.36</a:t>
            </a:r>
          </a:p>
        </p:txBody>
      </p:sp>
    </p:spTree>
    <p:extLst>
      <p:ext uri="{BB962C8B-B14F-4D97-AF65-F5344CB8AC3E}">
        <p14:creationId xmlns:p14="http://schemas.microsoft.com/office/powerpoint/2010/main" val="23326592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88C316E-AB84-4699-9621-23C71D7D8D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9749858"/>
              </p:ext>
            </p:extLst>
          </p:nvPr>
        </p:nvGraphicFramePr>
        <p:xfrm>
          <a:off x="4218240" y="3863065"/>
          <a:ext cx="2068512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10" r:id="rId3" imgW="2067937" imgH="2491654" progId="Prism10.Document">
                  <p:embed/>
                </p:oleObj>
              </mc:Choice>
              <mc:Fallback>
                <p:oleObj name="Prism 10" r:id="rId3" imgW="2067937" imgH="24916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18240" y="3863065"/>
                        <a:ext cx="2068512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7" name="TextBox 126">
            <a:extLst>
              <a:ext uri="{FF2B5EF4-FFF2-40B4-BE49-F238E27FC236}">
                <a16:creationId xmlns:a16="http://schemas.microsoft.com/office/drawing/2014/main" id="{DF5F3ED0-AB2E-9052-5F5B-40C9AFCF2D67}"/>
              </a:ext>
            </a:extLst>
          </p:cNvPr>
          <p:cNvSpPr txBox="1"/>
          <p:nvPr/>
        </p:nvSpPr>
        <p:spPr>
          <a:xfrm>
            <a:off x="195943" y="19206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3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3AF7A6F-83AA-3E7B-6870-ECEFBF05EB58}"/>
              </a:ext>
            </a:extLst>
          </p:cNvPr>
          <p:cNvSpPr txBox="1"/>
          <p:nvPr/>
        </p:nvSpPr>
        <p:spPr>
          <a:xfrm>
            <a:off x="159361" y="381973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BDF79DE-9FC4-4807-A180-FB7148290D67}"/>
              </a:ext>
            </a:extLst>
          </p:cNvPr>
          <p:cNvGrpSpPr/>
          <p:nvPr/>
        </p:nvGrpSpPr>
        <p:grpSpPr>
          <a:xfrm>
            <a:off x="3558989" y="92554"/>
            <a:ext cx="2570684" cy="2246156"/>
            <a:chOff x="190500" y="4243219"/>
            <a:chExt cx="2570684" cy="2246156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9A28732-B3F4-1ECC-D7B2-D5C3500573B3}"/>
                </a:ext>
              </a:extLst>
            </p:cNvPr>
            <p:cNvSpPr txBox="1"/>
            <p:nvPr/>
          </p:nvSpPr>
          <p:spPr>
            <a:xfrm>
              <a:off x="190500" y="4346418"/>
              <a:ext cx="630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CA8BF41-9976-90F2-FAE4-8022710C01B0}"/>
                </a:ext>
              </a:extLst>
            </p:cNvPr>
            <p:cNvSpPr txBox="1"/>
            <p:nvPr/>
          </p:nvSpPr>
          <p:spPr>
            <a:xfrm rot="16200000">
              <a:off x="-82803" y="5601952"/>
              <a:ext cx="14670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Helvetica" pitchFamily="2" charset="0"/>
                </a:rPr>
                <a:t>Clonality score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423C138-D99F-71A0-BB0D-4235B11765A3}"/>
                </a:ext>
              </a:extLst>
            </p:cNvPr>
            <p:cNvSpPr txBox="1"/>
            <p:nvPr/>
          </p:nvSpPr>
          <p:spPr>
            <a:xfrm>
              <a:off x="874322" y="4243219"/>
              <a:ext cx="188686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SARS-CoV-2 specific CD4 TCRB 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3C4EB1A3-82CE-4803-85AA-7C9C1B951F8D}"/>
              </a:ext>
            </a:extLst>
          </p:cNvPr>
          <p:cNvGrpSpPr/>
          <p:nvPr/>
        </p:nvGrpSpPr>
        <p:grpSpPr>
          <a:xfrm>
            <a:off x="401817" y="598757"/>
            <a:ext cx="2917718" cy="3007212"/>
            <a:chOff x="512952" y="648596"/>
            <a:chExt cx="2917718" cy="300721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332E1C7-908A-17B7-53B0-6BC03BA9BCC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3822" y="1046657"/>
              <a:ext cx="2488436" cy="248843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81FD8A3-56C3-E9C0-EF48-41E6836DB9DC}"/>
                </a:ext>
              </a:extLst>
            </p:cNvPr>
            <p:cNvSpPr txBox="1"/>
            <p:nvPr/>
          </p:nvSpPr>
          <p:spPr>
            <a:xfrm>
              <a:off x="512952" y="648596"/>
              <a:ext cx="122080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Helvetica" pitchFamily="2" charset="0"/>
                </a:rPr>
                <a:t>Non-SARS-CoV-2-specific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C77D2965-0E6F-62BF-4B1A-34DA66F4B8D9}"/>
                </a:ext>
              </a:extLst>
            </p:cNvPr>
            <p:cNvSpPr txBox="1"/>
            <p:nvPr/>
          </p:nvSpPr>
          <p:spPr>
            <a:xfrm>
              <a:off x="1085990" y="3378809"/>
              <a:ext cx="17271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err="1">
                  <a:solidFill>
                    <a:schemeClr val="tx1"/>
                  </a:solidFill>
                  <a:latin typeface="Helvetica" pitchFamily="2" charset="0"/>
                </a:rPr>
                <a:t>ImmuneCODE</a:t>
              </a:r>
              <a:endParaRPr lang="en-US" sz="1200" dirty="0">
                <a:solidFill>
                  <a:schemeClr val="tx1"/>
                </a:solidFill>
                <a:latin typeface="Helvetica" pitchFamily="2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864FDB8-D845-2514-7425-1E8848B0D9A8}"/>
                </a:ext>
              </a:extLst>
            </p:cNvPr>
            <p:cNvSpPr txBox="1"/>
            <p:nvPr/>
          </p:nvSpPr>
          <p:spPr>
            <a:xfrm>
              <a:off x="1678871" y="648596"/>
              <a:ext cx="1751799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Helvetica" pitchFamily="2" charset="0"/>
                </a:rPr>
                <a:t>SARS-CoV-2-specific from other resource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1E5A1BA-F677-4D72-B021-315C11981515}"/>
                </a:ext>
              </a:extLst>
            </p:cNvPr>
            <p:cNvSpPr txBox="1"/>
            <p:nvPr/>
          </p:nvSpPr>
          <p:spPr>
            <a:xfrm>
              <a:off x="2530066" y="1578527"/>
              <a:ext cx="407559" cy="253916"/>
            </a:xfrm>
            <a:prstGeom prst="rect">
              <a:avLst/>
            </a:prstGeom>
            <a:solidFill>
              <a:srgbClr val="FFD28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57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14A07AE-09C6-4DF9-B61B-032C0A575AC5}"/>
                </a:ext>
              </a:extLst>
            </p:cNvPr>
            <p:cNvSpPr txBox="1"/>
            <p:nvPr/>
          </p:nvSpPr>
          <p:spPr>
            <a:xfrm>
              <a:off x="1770543" y="1420896"/>
              <a:ext cx="407559" cy="253916"/>
            </a:xfrm>
            <a:prstGeom prst="rect">
              <a:avLst/>
            </a:prstGeom>
            <a:solidFill>
              <a:srgbClr val="FFD28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33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1C8B885-107B-45A7-86A9-BD25C212F0EC}"/>
                </a:ext>
              </a:extLst>
            </p:cNvPr>
            <p:cNvSpPr txBox="1"/>
            <p:nvPr/>
          </p:nvSpPr>
          <p:spPr>
            <a:xfrm>
              <a:off x="2350620" y="2335139"/>
              <a:ext cx="337670" cy="253916"/>
            </a:xfrm>
            <a:prstGeom prst="rect">
              <a:avLst/>
            </a:prstGeom>
            <a:solidFill>
              <a:srgbClr val="FFE84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3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622DD6E-E958-4BBE-93ED-8E88F0610CAC}"/>
                </a:ext>
              </a:extLst>
            </p:cNvPr>
            <p:cNvSpPr txBox="1"/>
            <p:nvPr/>
          </p:nvSpPr>
          <p:spPr>
            <a:xfrm>
              <a:off x="1789299" y="2037824"/>
              <a:ext cx="403091" cy="253916"/>
            </a:xfrm>
            <a:prstGeom prst="rect">
              <a:avLst/>
            </a:prstGeom>
            <a:solidFill>
              <a:srgbClr val="FFE84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11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649BB61-EFD5-46DD-8D53-0210F4783D14}"/>
                </a:ext>
              </a:extLst>
            </p:cNvPr>
            <p:cNvSpPr txBox="1"/>
            <p:nvPr/>
          </p:nvSpPr>
          <p:spPr>
            <a:xfrm>
              <a:off x="1745274" y="2926953"/>
              <a:ext cx="491140" cy="253916"/>
            </a:xfrm>
            <a:prstGeom prst="rect">
              <a:avLst/>
            </a:prstGeom>
            <a:solidFill>
              <a:srgbClr val="FFFF8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420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85BB099-7057-4DBE-9C78-3F4F1F6214CD}"/>
                </a:ext>
              </a:extLst>
            </p:cNvPr>
            <p:cNvSpPr txBox="1"/>
            <p:nvPr/>
          </p:nvSpPr>
          <p:spPr>
            <a:xfrm>
              <a:off x="1187731" y="2383088"/>
              <a:ext cx="491140" cy="253916"/>
            </a:xfrm>
            <a:prstGeom prst="rect">
              <a:avLst/>
            </a:prstGeom>
            <a:solidFill>
              <a:srgbClr val="FFFF80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201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A52C678-9873-4EC6-B6F9-74FB35A0AF74}"/>
                </a:ext>
              </a:extLst>
            </p:cNvPr>
            <p:cNvSpPr txBox="1"/>
            <p:nvPr/>
          </p:nvSpPr>
          <p:spPr>
            <a:xfrm>
              <a:off x="936773" y="1572991"/>
              <a:ext cx="568136" cy="253916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endParaRPr lang="en-US" sz="1050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163B83F-C230-4A17-9CB9-8F353A5F6313}"/>
                </a:ext>
              </a:extLst>
            </p:cNvPr>
            <p:cNvSpPr txBox="1"/>
            <p:nvPr/>
          </p:nvSpPr>
          <p:spPr>
            <a:xfrm>
              <a:off x="846336" y="1547854"/>
              <a:ext cx="82325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/>
                <a:t>76614842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2A6F6B24-E33D-4E74-ABAF-0EAF757BE9C3}"/>
              </a:ext>
            </a:extLst>
          </p:cNvPr>
          <p:cNvGrpSpPr/>
          <p:nvPr/>
        </p:nvGrpSpPr>
        <p:grpSpPr>
          <a:xfrm>
            <a:off x="127951" y="3784018"/>
            <a:ext cx="3622838" cy="2099064"/>
            <a:chOff x="89647" y="3959556"/>
            <a:chExt cx="3622838" cy="2099064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4490B159-5AAE-6B2B-6D39-4B0D51CD0419}"/>
                </a:ext>
              </a:extLst>
            </p:cNvPr>
            <p:cNvSpPr txBox="1"/>
            <p:nvPr/>
          </p:nvSpPr>
          <p:spPr>
            <a:xfrm>
              <a:off x="89647" y="4070831"/>
              <a:ext cx="630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20DDF31-45FD-4D71-A2E2-DAE7CBB58ED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3113" y="4391301"/>
              <a:ext cx="1667319" cy="1667319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E000C72-BF03-4084-A0C4-43D15CE04676}"/>
                </a:ext>
              </a:extLst>
            </p:cNvPr>
            <p:cNvSpPr txBox="1"/>
            <p:nvPr/>
          </p:nvSpPr>
          <p:spPr>
            <a:xfrm>
              <a:off x="602724" y="4058138"/>
              <a:ext cx="1647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All participants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A255478-6EA5-4C4D-A38D-2904614C8762}"/>
                </a:ext>
              </a:extLst>
            </p:cNvPr>
            <p:cNvSpPr txBox="1"/>
            <p:nvPr/>
          </p:nvSpPr>
          <p:spPr>
            <a:xfrm>
              <a:off x="2289517" y="3959556"/>
              <a:ext cx="1422968" cy="9387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7E7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GY (ORF10)</a:t>
              </a:r>
            </a:p>
            <a:p>
              <a:r>
                <a:rPr lang="en-US" sz="11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Q (Membrane)</a:t>
              </a:r>
            </a:p>
            <a:p>
              <a:r>
                <a:rPr lang="en-US" sz="1100" dirty="0">
                  <a:solidFill>
                    <a:srgbClr val="FFD57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Q (ORF7a)</a:t>
              </a:r>
            </a:p>
            <a:p>
              <a:r>
                <a:rPr lang="en-US" sz="1100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TS (Spike)</a:t>
              </a:r>
              <a:endParaRPr lang="en-US" sz="1100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100" dirty="0">
                  <a:solidFill>
                    <a:schemeClr val="bg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thers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A66AF8C6-74A4-4D5E-B55A-5E27035910CA}"/>
              </a:ext>
            </a:extLst>
          </p:cNvPr>
          <p:cNvGrpSpPr/>
          <p:nvPr/>
        </p:nvGrpSpPr>
        <p:grpSpPr>
          <a:xfrm>
            <a:off x="4816954" y="926074"/>
            <a:ext cx="932098" cy="210469"/>
            <a:chOff x="1696849" y="3884709"/>
            <a:chExt cx="932098" cy="210469"/>
          </a:xfrm>
        </p:grpSpPr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67279408-78E5-45AF-AA26-1133AB2F236F}"/>
                </a:ext>
              </a:extLst>
            </p:cNvPr>
            <p:cNvCxnSpPr>
              <a:cxnSpLocks/>
            </p:cNvCxnSpPr>
            <p:nvPr/>
          </p:nvCxnSpPr>
          <p:spPr>
            <a:xfrm>
              <a:off x="1696849" y="3965882"/>
              <a:ext cx="6324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A5ACF8A4-F2A6-41F7-A4B7-68E6DDF4733F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49" y="4051775"/>
              <a:ext cx="6324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C3177A1B-7532-473A-A6B4-075C8363B7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19317" y="3884709"/>
              <a:ext cx="0" cy="819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3BDE464F-3A83-4550-AB11-0BF4EDDEAB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44339" y="3884709"/>
              <a:ext cx="0" cy="164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BBF30A52-C205-472E-85CB-DDC560CB9FFB}"/>
                </a:ext>
              </a:extLst>
            </p:cNvPr>
            <p:cNvCxnSpPr>
              <a:cxnSpLocks/>
            </p:cNvCxnSpPr>
            <p:nvPr/>
          </p:nvCxnSpPr>
          <p:spPr>
            <a:xfrm>
              <a:off x="1816142" y="3891506"/>
              <a:ext cx="6324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5AC0023C-C2C6-4E91-A3A1-3B7D4C60415D}"/>
                </a:ext>
              </a:extLst>
            </p:cNvPr>
            <p:cNvCxnSpPr/>
            <p:nvPr/>
          </p:nvCxnSpPr>
          <p:spPr>
            <a:xfrm>
              <a:off x="1701766" y="3960558"/>
              <a:ext cx="0" cy="457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D7D71095-CB90-4E56-9952-357C90AD2AB1}"/>
                </a:ext>
              </a:extLst>
            </p:cNvPr>
            <p:cNvCxnSpPr/>
            <p:nvPr/>
          </p:nvCxnSpPr>
          <p:spPr>
            <a:xfrm>
              <a:off x="2328110" y="3959331"/>
              <a:ext cx="0" cy="457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14ECDDC7-0AF0-4525-87FF-DFAAD296DD0C}"/>
                </a:ext>
              </a:extLst>
            </p:cNvPr>
            <p:cNvCxnSpPr/>
            <p:nvPr/>
          </p:nvCxnSpPr>
          <p:spPr>
            <a:xfrm>
              <a:off x="2000216" y="4049458"/>
              <a:ext cx="0" cy="457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7BC14D93-9E0D-41B9-93D1-B8135642B680}"/>
                </a:ext>
              </a:extLst>
            </p:cNvPr>
            <p:cNvCxnSpPr/>
            <p:nvPr/>
          </p:nvCxnSpPr>
          <p:spPr>
            <a:xfrm>
              <a:off x="2626560" y="4045056"/>
              <a:ext cx="0" cy="457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E3DD46DA-08B4-4D75-BC9B-040AE0FE75E6}"/>
              </a:ext>
            </a:extLst>
          </p:cNvPr>
          <p:cNvSpPr txBox="1"/>
          <p:nvPr/>
        </p:nvSpPr>
        <p:spPr>
          <a:xfrm>
            <a:off x="4996628" y="65606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.07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89C1CF2-E4EA-E3D2-AA32-75A6F4745107}"/>
              </a:ext>
            </a:extLst>
          </p:cNvPr>
          <p:cNvSpPr txBox="1"/>
          <p:nvPr/>
        </p:nvSpPr>
        <p:spPr>
          <a:xfrm>
            <a:off x="195943" y="6147807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2CD25A1-88CC-47EB-B604-2C62056B49D6}"/>
              </a:ext>
            </a:extLst>
          </p:cNvPr>
          <p:cNvGrpSpPr/>
          <p:nvPr/>
        </p:nvGrpSpPr>
        <p:grpSpPr>
          <a:xfrm>
            <a:off x="3679892" y="3300778"/>
            <a:ext cx="2696342" cy="2913191"/>
            <a:chOff x="4398370" y="1694393"/>
            <a:chExt cx="2696342" cy="2913191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157AA45-C3F0-D6E5-EA24-655341563C6A}"/>
                </a:ext>
              </a:extLst>
            </p:cNvPr>
            <p:cNvSpPr txBox="1"/>
            <p:nvPr/>
          </p:nvSpPr>
          <p:spPr>
            <a:xfrm>
              <a:off x="4398370" y="2233023"/>
              <a:ext cx="630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3BF0F3CF-E3C6-40D8-B427-71950529510C}"/>
                </a:ext>
              </a:extLst>
            </p:cNvPr>
            <p:cNvGrpSpPr/>
            <p:nvPr/>
          </p:nvGrpSpPr>
          <p:grpSpPr>
            <a:xfrm>
              <a:off x="5740868" y="2646985"/>
              <a:ext cx="751791" cy="121569"/>
              <a:chOff x="1696849" y="3884709"/>
              <a:chExt cx="751791" cy="121569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A278A2BE-970E-48B5-9117-CE1792D47E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6849" y="3965882"/>
                <a:ext cx="230106" cy="7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>
                <a:extLst>
                  <a:ext uri="{FF2B5EF4-FFF2-40B4-BE49-F238E27FC236}">
                    <a16:creationId xmlns:a16="http://schemas.microsoft.com/office/drawing/2014/main" id="{EEC781A7-33FC-429C-86B3-03B4B9B2A8D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19317" y="3884709"/>
                <a:ext cx="0" cy="8191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DF9318BA-A687-427E-AA3C-52EBEFDBA1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44339" y="3884709"/>
                <a:ext cx="0" cy="8117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109AF47B-3AFE-48D2-9339-FFD758F55D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16142" y="3891506"/>
                <a:ext cx="63249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C2B018CE-0479-4E6B-B501-466C43769AEC}"/>
                  </a:ext>
                </a:extLst>
              </p:cNvPr>
              <p:cNvCxnSpPr/>
              <p:nvPr/>
            </p:nvCxnSpPr>
            <p:spPr>
              <a:xfrm>
                <a:off x="1701766" y="3960558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19EB72F5-04F4-4F8A-B479-85ADEED8D526}"/>
                  </a:ext>
                </a:extLst>
              </p:cNvPr>
              <p:cNvCxnSpPr/>
              <p:nvPr/>
            </p:nvCxnSpPr>
            <p:spPr>
              <a:xfrm>
                <a:off x="1920440" y="3959331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2ECFB10-732C-4CF7-A2E3-4697062F9E31}"/>
                </a:ext>
              </a:extLst>
            </p:cNvPr>
            <p:cNvSpPr txBox="1"/>
            <p:nvPr/>
          </p:nvSpPr>
          <p:spPr>
            <a:xfrm>
              <a:off x="5888859" y="2408552"/>
              <a:ext cx="5325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4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E899B19-1728-4700-930E-99E39DE78038}"/>
                </a:ext>
              </a:extLst>
            </p:cNvPr>
            <p:cNvSpPr txBox="1"/>
            <p:nvPr/>
          </p:nvSpPr>
          <p:spPr>
            <a:xfrm>
              <a:off x="5674823" y="2869028"/>
              <a:ext cx="1847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400" dirty="0">
                <a:latin typeface="Helvetica" pitchFamily="2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D3B5FAE2-01F2-4E77-B87C-804E5714176D}"/>
                </a:ext>
              </a:extLst>
            </p:cNvPr>
            <p:cNvSpPr txBox="1"/>
            <p:nvPr/>
          </p:nvSpPr>
          <p:spPr>
            <a:xfrm rot="16200000">
              <a:off x="3712833" y="3320624"/>
              <a:ext cx="22661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US" sz="1400" b="1" dirty="0">
                <a:latin typeface="Helvetica" pitchFamily="2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A201645B-A571-4579-89B5-B578ADEB2B55}"/>
                </a:ext>
              </a:extLst>
            </p:cNvPr>
            <p:cNvSpPr txBox="1"/>
            <p:nvPr/>
          </p:nvSpPr>
          <p:spPr>
            <a:xfrm>
              <a:off x="5207850" y="1694393"/>
              <a:ext cx="18868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Spike 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1B03E262-DB8E-4518-A599-7FC2E844C749}"/>
                </a:ext>
              </a:extLst>
            </p:cNvPr>
            <p:cNvSpPr txBox="1"/>
            <p:nvPr/>
          </p:nvSpPr>
          <p:spPr>
            <a:xfrm rot="16200000">
              <a:off x="3778754" y="3217537"/>
              <a:ext cx="207828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% Antigen-specific CD4 TCRB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077A2349-9CA0-41EE-908C-312F1528A521}"/>
              </a:ext>
            </a:extLst>
          </p:cNvPr>
          <p:cNvGrpSpPr/>
          <p:nvPr/>
        </p:nvGrpSpPr>
        <p:grpSpPr>
          <a:xfrm>
            <a:off x="417153" y="6077997"/>
            <a:ext cx="2112880" cy="2349919"/>
            <a:chOff x="4060326" y="5458782"/>
            <a:chExt cx="2112880" cy="2349919"/>
          </a:xfrm>
        </p:grpSpPr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67C0E0A-5B19-4576-8C98-0AECCC6C04CC}"/>
                </a:ext>
              </a:extLst>
            </p:cNvPr>
            <p:cNvSpPr txBox="1"/>
            <p:nvPr/>
          </p:nvSpPr>
          <p:spPr>
            <a:xfrm>
              <a:off x="4286344" y="5458782"/>
              <a:ext cx="18868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Spike 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58B2DBB1-7655-446F-9491-01DFC0FD183D}"/>
                </a:ext>
              </a:extLst>
            </p:cNvPr>
            <p:cNvSpPr txBox="1"/>
            <p:nvPr/>
          </p:nvSpPr>
          <p:spPr>
            <a:xfrm rot="16200000">
              <a:off x="3282794" y="6507950"/>
              <a:ext cx="207828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Helvetica" pitchFamily="2" charset="0"/>
                </a:rPr>
                <a:t>% Antigen-specific CD4 TCRB</a:t>
              </a:r>
            </a:p>
          </p:txBody>
        </p:sp>
      </p:grp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D176D7C-2091-4D57-9915-8CF9557FE0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344431"/>
              </p:ext>
            </p:extLst>
          </p:nvPr>
        </p:nvGraphicFramePr>
        <p:xfrm>
          <a:off x="4198023" y="748668"/>
          <a:ext cx="1976438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10" r:id="rId7" imgW="1976509" imgH="2491654" progId="Prism10.Document">
                  <p:embed/>
                </p:oleObj>
              </mc:Choice>
              <mc:Fallback>
                <p:oleObj name="Prism 10" r:id="rId7" imgW="1976509" imgH="24916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98023" y="748668"/>
                        <a:ext cx="1976438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718DCE11-BF41-440E-9BA3-66B2B7BEF6DB}"/>
              </a:ext>
            </a:extLst>
          </p:cNvPr>
          <p:cNvCxnSpPr>
            <a:cxnSpLocks/>
          </p:cNvCxnSpPr>
          <p:nvPr/>
        </p:nvCxnSpPr>
        <p:spPr>
          <a:xfrm>
            <a:off x="5654827" y="4335456"/>
            <a:ext cx="230106" cy="74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3C06DF01-1D93-474E-B866-17DA8C46C4D8}"/>
              </a:ext>
            </a:extLst>
          </p:cNvPr>
          <p:cNvCxnSpPr/>
          <p:nvPr/>
        </p:nvCxnSpPr>
        <p:spPr>
          <a:xfrm>
            <a:off x="5659744" y="4330132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B3B5C5B6-F9EB-498C-A5DB-AF3A7AE19ED3}"/>
              </a:ext>
            </a:extLst>
          </p:cNvPr>
          <p:cNvCxnSpPr/>
          <p:nvPr/>
        </p:nvCxnSpPr>
        <p:spPr>
          <a:xfrm>
            <a:off x="5878418" y="4328905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E13A7B85-F0FC-4D4C-B385-8847185DD5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5717789"/>
              </p:ext>
            </p:extLst>
          </p:nvPr>
        </p:nvGraphicFramePr>
        <p:xfrm>
          <a:off x="917326" y="6329565"/>
          <a:ext cx="2909888" cy="2025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Prism 10" r:id="rId9" imgW="2910590" imgH="2025144" progId="Prism10.Document">
                  <p:embed/>
                </p:oleObj>
              </mc:Choice>
              <mc:Fallback>
                <p:oleObj name="Prism 10" r:id="rId9" imgW="2910590" imgH="202514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17326" y="6329565"/>
                        <a:ext cx="2909888" cy="2025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033940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9646E65-0FA3-4ECF-ABFA-E1667F0459E0}"/>
              </a:ext>
            </a:extLst>
          </p:cNvPr>
          <p:cNvSpPr txBox="1"/>
          <p:nvPr/>
        </p:nvSpPr>
        <p:spPr>
          <a:xfrm>
            <a:off x="89647" y="125129"/>
            <a:ext cx="6768353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3.  Pattern of SARS-CoV-2-specific CD4 TCRB and common epitopes recognized by clinical disease and vaccination status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ematic illustration of the approach to identifying SARS-CoV-2-specific CD4 TCRBs using the pre-pandemic sequencing data (white),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mmuneCODE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atabase (yellow) and other published SARS-CoV-2-specific CD4 TCRB (orange). </a:t>
            </a:r>
          </a:p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clonality of SARS-CoV-2-specific CD4 TCRB among study groups. P values show significance based on Mann-Whitney test. </a:t>
            </a:r>
          </a:p>
          <a:p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ARS-CoV-2-specific CD4 TCRB peptide recognition distribution in all participants. The slices represent the top 4 most commonly recognized peptides; MGYINVFAFPFTIYSLLLC (MYG) from ORF10, SRTLSYYKLGASQRVAGDS (ASQ) from Membrane, STQFAFACPDGVKHVYQ (STQ) from ORF7a,  YTSALLAGTITSGWTFGAG (YTS) from Spike.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D) Frequency of Spike-specific CD4 TCRB among study groups. P values indicate significance by Mann-Whitney test.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E) Frequencies of Spike-specific CD4 TCRB measured in primary (red) and vaccine breakthrough (blue) participants by 14 to 16 and 18 to 21 days post symptom onset. P values indicate the significance by Mann-Whitney test.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21024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24E7FE-4C61-6302-8A3E-AFF28787BE5F}"/>
              </a:ext>
            </a:extLst>
          </p:cNvPr>
          <p:cNvSpPr txBox="1"/>
          <p:nvPr/>
        </p:nvSpPr>
        <p:spPr>
          <a:xfrm>
            <a:off x="1235851" y="651884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1:01:0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DAFAE07-05B6-AC19-8D18-64EF8FFB9796}"/>
              </a:ext>
            </a:extLst>
          </p:cNvPr>
          <p:cNvSpPr txBox="1"/>
          <p:nvPr/>
        </p:nvSpPr>
        <p:spPr>
          <a:xfrm>
            <a:off x="2890921" y="651884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2:01:0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7CC018-1C73-A485-BBEE-3CD23168B88C}"/>
              </a:ext>
            </a:extLst>
          </p:cNvPr>
          <p:cNvSpPr txBox="1"/>
          <p:nvPr/>
        </p:nvSpPr>
        <p:spPr>
          <a:xfrm>
            <a:off x="4083182" y="651884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3:01: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A011480-CF40-48EF-C90E-7B798DEACC45}"/>
              </a:ext>
            </a:extLst>
          </p:cNvPr>
          <p:cNvSpPr txBox="1"/>
          <p:nvPr/>
        </p:nvSpPr>
        <p:spPr>
          <a:xfrm>
            <a:off x="5373221" y="651884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68:01:0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5771F7-A23C-5199-E35D-5623F42F8F36}"/>
              </a:ext>
            </a:extLst>
          </p:cNvPr>
          <p:cNvSpPr txBox="1"/>
          <p:nvPr/>
        </p:nvSpPr>
        <p:spPr>
          <a:xfrm rot="16200000">
            <a:off x="-948455" y="1919132"/>
            <a:ext cx="28761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Helvetica" pitchFamily="2" charset="0"/>
              </a:rPr>
              <a:t>%TCRB specific for peptid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51C65D3-6C47-959E-B061-491958E462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293" y="831467"/>
            <a:ext cx="1866900" cy="3860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E170731-4048-BE75-A4CD-5B7B7FF12F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4707" y="828480"/>
            <a:ext cx="1752600" cy="3352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5B0DE11-6D16-A79C-D965-2AE2DB45F4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9667" y="828480"/>
            <a:ext cx="1727200" cy="3860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73D63FB-BF67-B4D8-DA0C-BEEE883A55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64545" y="828480"/>
            <a:ext cx="1727200" cy="38608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EB7CEBD-F90B-A59B-9186-69D78D0DC877}"/>
              </a:ext>
            </a:extLst>
          </p:cNvPr>
          <p:cNvSpPr txBox="1"/>
          <p:nvPr/>
        </p:nvSpPr>
        <p:spPr>
          <a:xfrm>
            <a:off x="1039220" y="4819909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7:02:0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BB02306-A337-1E20-E634-0C2BC72144B1}"/>
              </a:ext>
            </a:extLst>
          </p:cNvPr>
          <p:cNvSpPr txBox="1"/>
          <p:nvPr/>
        </p:nvSpPr>
        <p:spPr>
          <a:xfrm>
            <a:off x="2421011" y="4819908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8:01:0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A83C4C-731A-F3AD-12EA-9A1859402C38}"/>
              </a:ext>
            </a:extLst>
          </p:cNvPr>
          <p:cNvSpPr txBox="1"/>
          <p:nvPr/>
        </p:nvSpPr>
        <p:spPr>
          <a:xfrm>
            <a:off x="3907834" y="4819908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15:01:0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5FCDC51-C3EF-FAD5-C4BD-D44858B3CE2A}"/>
              </a:ext>
            </a:extLst>
          </p:cNvPr>
          <p:cNvSpPr txBox="1"/>
          <p:nvPr/>
        </p:nvSpPr>
        <p:spPr>
          <a:xfrm rot="16200000">
            <a:off x="-948456" y="6072928"/>
            <a:ext cx="28761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Helvetica" pitchFamily="2" charset="0"/>
              </a:rPr>
              <a:t>%TCRB specific for peptide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410E78A7-1BCA-22AF-8C40-0076FD3A60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2292" y="5096908"/>
            <a:ext cx="1727200" cy="38608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699DB09-F972-1EA9-1E19-4CD6B985FD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18772" y="5160408"/>
            <a:ext cx="1727200" cy="37973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9D2F6FA-3593-B2C3-5AE6-EA4B743BF82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60385" y="5096907"/>
            <a:ext cx="1727200" cy="37846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58F8F14A-BCFB-9DCB-986F-B18A4030F8D7}"/>
              </a:ext>
            </a:extLst>
          </p:cNvPr>
          <p:cNvSpPr txBox="1"/>
          <p:nvPr/>
        </p:nvSpPr>
        <p:spPr>
          <a:xfrm>
            <a:off x="41564" y="35626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ECDDB44-F5BA-0D5E-1071-3EBAB3E47A91}"/>
              </a:ext>
            </a:extLst>
          </p:cNvPr>
          <p:cNvSpPr txBox="1"/>
          <p:nvPr/>
        </p:nvSpPr>
        <p:spPr>
          <a:xfrm>
            <a:off x="18038" y="453831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CEECE39-213C-1DAC-3E37-AF07D40921B6}"/>
              </a:ext>
            </a:extLst>
          </p:cNvPr>
          <p:cNvSpPr txBox="1"/>
          <p:nvPr/>
        </p:nvSpPr>
        <p:spPr>
          <a:xfrm>
            <a:off x="18037" y="4662209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796508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E1BA46D-DA3F-A91E-D523-30D3184E43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6654" y="400145"/>
            <a:ext cx="1727200" cy="33528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B2CB454-9E19-9EB1-F40B-2C465D59122A}"/>
              </a:ext>
            </a:extLst>
          </p:cNvPr>
          <p:cNvSpPr txBox="1"/>
          <p:nvPr/>
        </p:nvSpPr>
        <p:spPr>
          <a:xfrm>
            <a:off x="3003915" y="139266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44:03:0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62B7C03-AD13-282A-327C-203223032118}"/>
              </a:ext>
            </a:extLst>
          </p:cNvPr>
          <p:cNvSpPr txBox="1"/>
          <p:nvPr/>
        </p:nvSpPr>
        <p:spPr>
          <a:xfrm>
            <a:off x="864972" y="139266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18:01:0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13D8AA9-798D-D259-8E13-4E6011BA6E26}"/>
              </a:ext>
            </a:extLst>
          </p:cNvPr>
          <p:cNvSpPr txBox="1"/>
          <p:nvPr/>
        </p:nvSpPr>
        <p:spPr>
          <a:xfrm>
            <a:off x="1862731" y="139266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44:02:0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050AA19-0EF4-5D82-63E1-ABA50CFA63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876" y="402195"/>
            <a:ext cx="1727200" cy="304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459E30F-E6E5-3588-6ACE-030EF9850A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9380" y="402195"/>
            <a:ext cx="1727200" cy="37846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0987755-39E1-5A6D-6AFD-D1AC234BC30A}"/>
              </a:ext>
            </a:extLst>
          </p:cNvPr>
          <p:cNvSpPr txBox="1"/>
          <p:nvPr/>
        </p:nvSpPr>
        <p:spPr>
          <a:xfrm rot="16200000">
            <a:off x="-948455" y="1337238"/>
            <a:ext cx="28761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Helvetica" pitchFamily="2" charset="0"/>
              </a:rPr>
              <a:t>%TCRB specific for peptid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E95973-5D14-E688-FD47-9AF2A76EED5A}"/>
              </a:ext>
            </a:extLst>
          </p:cNvPr>
          <p:cNvSpPr txBox="1"/>
          <p:nvPr/>
        </p:nvSpPr>
        <p:spPr>
          <a:xfrm>
            <a:off x="1217867" y="4169445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3:03:0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911821-668B-C293-747B-5A2A91DE7B97}"/>
              </a:ext>
            </a:extLst>
          </p:cNvPr>
          <p:cNvSpPr txBox="1"/>
          <p:nvPr/>
        </p:nvSpPr>
        <p:spPr>
          <a:xfrm>
            <a:off x="2417802" y="4169445"/>
            <a:ext cx="780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6:02:0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F1104A-3F7B-48A7-8B84-8D5B3BCA04B3}"/>
              </a:ext>
            </a:extLst>
          </p:cNvPr>
          <p:cNvSpPr txBox="1"/>
          <p:nvPr/>
        </p:nvSpPr>
        <p:spPr>
          <a:xfrm>
            <a:off x="3684404" y="4169445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7:103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E1F06E5-3EAD-39B3-C02A-D14B0438D148}"/>
              </a:ext>
            </a:extLst>
          </p:cNvPr>
          <p:cNvSpPr txBox="1"/>
          <p:nvPr/>
        </p:nvSpPr>
        <p:spPr>
          <a:xfrm>
            <a:off x="5043521" y="4169443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7:863N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1F478E6-4F53-ED8D-ECB8-8A05D1378B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6135" y="4307943"/>
            <a:ext cx="1727200" cy="3784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03F4759-3A2E-1CB4-2F63-00A7B27414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98712" y="4307943"/>
            <a:ext cx="1727200" cy="33528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D10D7E1-0B8F-EEAF-8573-691E5142DD4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95933" y="4303201"/>
            <a:ext cx="1727200" cy="3784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80F52F7-35FC-5871-7549-73085D6758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55917" y="4303201"/>
            <a:ext cx="1727200" cy="39116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3DE28D5-5186-928E-2851-D7804AFDF239}"/>
              </a:ext>
            </a:extLst>
          </p:cNvPr>
          <p:cNvSpPr txBox="1"/>
          <p:nvPr/>
        </p:nvSpPr>
        <p:spPr>
          <a:xfrm rot="16200000">
            <a:off x="-948456" y="5449571"/>
            <a:ext cx="28761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Helvetica" pitchFamily="2" charset="0"/>
              </a:rPr>
              <a:t>%TCRB specific for peptid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4FA528-497C-B48D-988D-E75D01B470A8}"/>
              </a:ext>
            </a:extLst>
          </p:cNvPr>
          <p:cNvSpPr txBox="1"/>
          <p:nvPr/>
        </p:nvSpPr>
        <p:spPr>
          <a:xfrm>
            <a:off x="18038" y="3918471"/>
            <a:ext cx="6304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B2AD19-4622-D7BF-B776-04405FFFC465}"/>
              </a:ext>
            </a:extLst>
          </p:cNvPr>
          <p:cNvSpPr txBox="1"/>
          <p:nvPr/>
        </p:nvSpPr>
        <p:spPr>
          <a:xfrm>
            <a:off x="0" y="8130225"/>
            <a:ext cx="6858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The most common HLA-A (A) -B (B) and -C (C) haplotypes among the COVID-19 participants in this study and the recognized epitopes. A haplotype was plotted if it was expressed by 4 or more participants. The dotted line represents 0.002% of TCRBs specific for the peptide within a participant. Black dots indicate epitopes with TCRB frequencies above 0.002% for all participants within the HLA-I haplotype. </a:t>
            </a:r>
          </a:p>
        </p:txBody>
      </p:sp>
    </p:spTree>
    <p:extLst>
      <p:ext uri="{BB962C8B-B14F-4D97-AF65-F5344CB8AC3E}">
        <p14:creationId xmlns:p14="http://schemas.microsoft.com/office/powerpoint/2010/main" val="1018864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4048</TotalTime>
  <Words>503</Words>
  <Application>Microsoft Office PowerPoint</Application>
  <PresentationFormat>Letter Paper (8.5x11 in)</PresentationFormat>
  <Paragraphs>8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Helvetica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ngyan Lu</dc:creator>
  <cp:lastModifiedBy>EMILY PARSONS</cp:lastModifiedBy>
  <cp:revision>283</cp:revision>
  <dcterms:created xsi:type="dcterms:W3CDTF">2024-07-18T20:17:57Z</dcterms:created>
  <dcterms:modified xsi:type="dcterms:W3CDTF">2025-07-22T14:17:51Z</dcterms:modified>
</cp:coreProperties>
</file>